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8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661866-76CA-81B6-6263-E1826592F2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2B7E9E-8CA0-3EA7-8533-784C27B397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8A99C5-31AD-7B18-10F4-515F0ACBF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1CAD73-045F-0EE9-A0F5-37DCC0D28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D7D329-807A-50D7-E5BF-77CFF28FE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17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AE61F-C9BF-95A6-2653-E525583A23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B0E83A-1095-656A-CA30-9D61193E5A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C8BCC-06D2-B36F-C74D-CBB8AAC6D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82110A-8624-A155-B1FD-43B81E6452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B60B5B-7352-AA83-A438-D5D303FBA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173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A762CB-0A6B-D3D2-4D6F-B178380407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AB4640-BD49-6813-7AF7-312A0B980F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4D5CE6-F170-1697-A7E3-3DAA961E1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629D73-8DBC-098D-6553-2081B4B31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D3BE2D-6DEC-5CDB-2AFD-B4E717D21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695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B1B831-7F1B-182B-AA8C-2D4445DD56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EC1F52-44AC-CB95-5247-B9D37CE680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32F588-206E-E177-55D6-8BC350F21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1ACC96-8640-CA6B-588C-6276C5BB3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796936-CC5C-576D-FC00-369055A31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989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3E68B9-7404-E3F4-232D-24549CDE82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801A76-59E9-B8EF-21D2-C2E3669AA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AD9C58-E797-80D7-BEE2-9D895E131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E12165-771C-2D21-E38E-034B3D375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9D6CF6-C61A-9D8B-06EA-969E7BBEF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361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7D77B-1510-8EFF-A01E-6D05180B57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B0CC06-BEE0-AEEA-C30E-9FCD4199F4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F5BAF8-B8D4-8621-6C22-859BAF0365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218FC8-75C3-971F-4004-0A4AE2262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05CB45-FCEE-BB8E-D664-E3395DF46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497DE2-BCEF-2C5B-3250-09B08520C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791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660691-1A47-B740-537A-EF8E639FA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0AEB90-B86E-45F0-8596-8920BF85FD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DD8607-3E10-515D-D78D-A3519C92A0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30AD4B-5BEB-7073-2FEB-062FCC8246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674690-B4AC-D644-30E3-C6E65DC458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ED19F7B-5AA4-4087-BE6C-67A5E0DE4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66E49E2-12D1-E71C-C81C-90DFE0929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FA9AE26-3BB0-0BCA-4C87-E14E45E03B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115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9A8EFD-9E1D-CA87-2929-92A9CDF7CA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746C98-486A-5B03-00C0-DA207437F9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DFE59A3-3902-381D-E72B-6454AA8C0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C6E09A-2895-3A83-F429-4922696AF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716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5A0FD0A-BFD2-A200-4BBA-40E7A4173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423EC67-9750-0464-9766-374EE9A4C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892AE66-CB7F-E121-BE53-CE118FB16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80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BC4CFC-8E04-5BB8-C6F1-B235A7310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8C4F97-C19F-E003-4E8A-298D5CD602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A4C2E4-F9CC-014E-C100-00D7BAA426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704618-E88A-9CC2-E18E-EF41BF6ED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1FA5ED-6C44-845F-CC5E-7120C79CD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B52414-421B-82A2-3150-FE38DA8ED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852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8EA664-CD5C-40EA-36E6-88C27EED09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81D1141-07DD-543F-A6F0-B7E2161B13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4683EC-FFF4-C3DB-6F6A-0375CDFF88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C6BFFF-A981-7FE6-9772-9B8AD2E30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B24FAD-98CC-F125-2870-84DF6C147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B0EFE1-6A20-F6D1-251E-2BF48E6097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227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3CEB679-EE00-3717-17AD-47D75682D8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04724B-27CC-0331-C75E-3CA09C8966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0ED1D4-F0BB-4C12-8A96-2DF662895E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543417-3A86-1B41-AAB4-1C0DDB578DC8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E3051-7763-912B-A2C7-7EA65D7E2E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4DD8A2-6D0E-C98D-4E00-7C74AB0296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19939C-B439-5746-9AFB-A40F0DD6C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475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8361343-CE8A-1A9C-7BD8-46DE5D6EA2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5162011"/>
              </p:ext>
            </p:extLst>
          </p:nvPr>
        </p:nvGraphicFramePr>
        <p:xfrm>
          <a:off x="2730500" y="1468160"/>
          <a:ext cx="7711223" cy="293370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008688">
                  <a:extLst>
                    <a:ext uri="{9D8B030D-6E8A-4147-A177-3AD203B41FA5}">
                      <a16:colId xmlns:a16="http://schemas.microsoft.com/office/drawing/2014/main" val="81183664"/>
                    </a:ext>
                  </a:extLst>
                </a:gridCol>
                <a:gridCol w="1881281">
                  <a:extLst>
                    <a:ext uri="{9D8B030D-6E8A-4147-A177-3AD203B41FA5}">
                      <a16:colId xmlns:a16="http://schemas.microsoft.com/office/drawing/2014/main" val="1836190397"/>
                    </a:ext>
                  </a:extLst>
                </a:gridCol>
                <a:gridCol w="2410627">
                  <a:extLst>
                    <a:ext uri="{9D8B030D-6E8A-4147-A177-3AD203B41FA5}">
                      <a16:colId xmlns:a16="http://schemas.microsoft.com/office/drawing/2014/main" val="2653859059"/>
                    </a:ext>
                  </a:extLst>
                </a:gridCol>
                <a:gridCol w="2410627">
                  <a:extLst>
                    <a:ext uri="{9D8B030D-6E8A-4147-A177-3AD203B41FA5}">
                      <a16:colId xmlns:a16="http://schemas.microsoft.com/office/drawing/2014/main" val="3788086473"/>
                    </a:ext>
                  </a:extLst>
                </a:gridCol>
              </a:tblGrid>
              <a:tr h="426720">
                <a:tc gridSpan="4">
                  <a:txBody>
                    <a:bodyPr/>
                    <a:lstStyle/>
                    <a:p>
                      <a:pPr lvl="0" algn="l">
                        <a:buNone/>
                      </a:pPr>
                      <a:r>
                        <a:rPr lang="en-US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pplemental Table S4:   </a:t>
                      </a:r>
                      <a:r>
                        <a:rPr lang="en-US" sz="11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ssociation of NLR with improved cancer outcome by odds ratio (OR, 95% CI)</a:t>
                      </a:r>
                    </a:p>
                  </a:txBody>
                  <a:tcPr marL="55562" marR="55562" marT="38100" marB="38100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6674" marR="66674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66674" marR="66674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vl="0" algn="l">
                        <a:buNone/>
                      </a:pPr>
                      <a:endParaRPr lang="en-US" sz="2600" b="0" i="0" u="none" strike="noStrike" noProof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33347" marR="133347" marT="91440" marB="91440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9602921"/>
                  </a:ext>
                </a:extLst>
              </a:tr>
              <a:tr h="510540">
                <a:tc>
                  <a:txBody>
                    <a:bodyPr/>
                    <a:lstStyle/>
                    <a:p>
                      <a:pPr algn="ctr" rtl="0" fontAlgn="base"/>
                      <a:endParaRPr lang="en-US" sz="11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4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Cumulative Logistic model, unadjusted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Cumulative Logistic</a:t>
                      </a:r>
                      <a:r>
                        <a:rPr lang="en-US" sz="900" b="1" baseline="30000" dirty="0">
                          <a:effectLst/>
                          <a:latin typeface="+mn-lt"/>
                        </a:rPr>
                        <a:t>1,2</a:t>
                      </a:r>
                      <a:r>
                        <a:rPr lang="en-US" sz="900" b="1" dirty="0">
                          <a:effectLst/>
                          <a:latin typeface="+mn-lt"/>
                        </a:rPr>
                        <a:t> model adjusted by age, sex, and ICI therapy</a:t>
                      </a:r>
                      <a:r>
                        <a:rPr lang="en-US" sz="900" b="1" baseline="30000" dirty="0">
                          <a:effectLst/>
                          <a:latin typeface="+mn-lt"/>
                        </a:rPr>
                        <a:t>1</a:t>
                      </a:r>
                      <a:r>
                        <a:rPr lang="en-US" sz="900" b="1" dirty="0">
                          <a:effectLst/>
                          <a:latin typeface="+mn-lt"/>
                        </a:rPr>
                        <a:t> </a:t>
                      </a: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4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umulative Logistic</a:t>
                      </a:r>
                      <a:r>
                        <a:rPr lang="en-US" sz="900" b="1" i="0" u="none" strike="noStrike" baseline="30000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,2</a:t>
                      </a:r>
                      <a:r>
                        <a:rPr lang="en-US" sz="9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model additionally adjusted for ECOG score (≥1 vs 0) and cancer stage (4 vs &lt;4), sample size 94</a:t>
                      </a:r>
                    </a:p>
                  </a:txBody>
                  <a:tcPr marL="66675" marR="66675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8554163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Risk factor:  </a:t>
                      </a:r>
                      <a:endParaRPr lang="en-US" sz="1800" b="1" dirty="0">
                        <a:effectLst/>
                        <a:latin typeface="+mn-lt"/>
                      </a:endParaRPr>
                    </a:p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NLR definition </a:t>
                      </a:r>
                      <a:endParaRPr lang="en-US" sz="1800" b="1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OR (95% CI) </a:t>
                      </a:r>
                      <a:endParaRPr lang="en-US" sz="1800" b="1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dirty="0">
                          <a:effectLst/>
                          <a:latin typeface="+mn-lt"/>
                        </a:rPr>
                        <a:t>aOR (95% CI) </a:t>
                      </a:r>
                      <a:endParaRPr lang="en-US" sz="1800" b="1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b="1" dirty="0">
                          <a:effectLst/>
                          <a:latin typeface="+mn-lt"/>
                        </a:rPr>
                        <a:t>aOR (95% CI)</a:t>
                      </a:r>
                    </a:p>
                  </a:txBody>
                  <a:tcPr marL="66675" marR="66675" anchor="ctr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9524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1304607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continuous ln(NLR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78 (0.53, 1.15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74 (0.49, 1.13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en-US" sz="9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 w="0">
                      <a:noFill/>
                    </a:lnL>
                    <a:lnR w="0">
                      <a:noFill/>
                    </a:lnR>
                    <a:lnT w="9524">
                      <a:solidFill>
                        <a:srgbClr val="000000"/>
                      </a:solidFill>
                    </a:lnT>
                    <a:lnB w="0"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576602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NLR&lt;4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76 (0.36, 1.59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76 (0.36, 1.61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  <a:latin typeface="+mn-lt"/>
                        </a:rPr>
                        <a:t>0.64 (0.27, 1.49)</a:t>
                      </a:r>
                    </a:p>
                  </a:txBody>
                  <a:tcPr marL="66675" marR="66675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0"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116415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NLR&lt;5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87 (0.39, 1.94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75 (0.33, 1.71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900" dirty="0">
                          <a:effectLst/>
                          <a:latin typeface="+mn-lt"/>
                        </a:rPr>
                        <a:t>0.78 (0.31, 1.93)</a:t>
                      </a:r>
                    </a:p>
                  </a:txBody>
                  <a:tcPr marL="66675" marR="66675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0"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716914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continuous ln(N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99 (0.67, 1.46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99 (0.67, 1.47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en-US" sz="9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0"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4149790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continuous ln(L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dirty="0">
                          <a:effectLst/>
                          <a:latin typeface="+mn-lt"/>
                        </a:rPr>
                        <a:t>0.74 (0.50, 1.09)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1" i="1" dirty="0">
                          <a:effectLst/>
                          <a:latin typeface="+mn-lt"/>
                        </a:rPr>
                        <a:t>0.70 (0.46, 1.07)</a:t>
                      </a:r>
                      <a:r>
                        <a:rPr lang="en-US" sz="900" dirty="0">
                          <a:effectLst/>
                          <a:latin typeface="+mn-lt"/>
                        </a:rPr>
                        <a:t> </a:t>
                      </a:r>
                      <a:endParaRPr lang="en-US" sz="18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endParaRPr lang="en-US" sz="900" dirty="0">
                        <a:effectLst/>
                        <a:latin typeface="+mn-lt"/>
                      </a:endParaRPr>
                    </a:p>
                  </a:txBody>
                  <a:tcPr marL="66675" marR="66675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9524">
                      <a:solidFill>
                        <a:srgbClr val="000000"/>
                      </a:solidFill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195550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6D36268-0F23-D713-5836-980F0D9B418E}"/>
              </a:ext>
            </a:extLst>
          </p:cNvPr>
          <p:cNvSpPr txBox="1"/>
          <p:nvPr/>
        </p:nvSpPr>
        <p:spPr>
          <a:xfrm>
            <a:off x="2727960" y="4414520"/>
            <a:ext cx="6868160" cy="50013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38100" tIns="19050" rIns="38100" bIns="1905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750" baseline="30000" dirty="0">
                <a:ea typeface="+mn-lt"/>
                <a:cs typeface="+mn-lt"/>
              </a:rPr>
              <a:t>1</a:t>
            </a:r>
            <a:r>
              <a:rPr lang="en-US" sz="750" dirty="0">
                <a:ea typeface="+mn-lt"/>
                <a:cs typeface="+mn-lt"/>
              </a:rPr>
              <a:t>Partial proportional odds model. Tested for interactions with age, sex, and ICI therapy (combination or IPI only) and shown as such when p-value for interaction is &lt;0.10 </a:t>
            </a:r>
            <a:endParaRPr lang="en-US" sz="750">
              <a:ea typeface="Calibri" panose="020F0502020204030204"/>
              <a:cs typeface="Calibri" panose="020F0502020204030204"/>
            </a:endParaRPr>
          </a:p>
          <a:p>
            <a:r>
              <a:rPr lang="en-US" sz="750" baseline="30000" dirty="0">
                <a:ea typeface="+mn-lt"/>
                <a:cs typeface="+mn-lt"/>
              </a:rPr>
              <a:t>2</a:t>
            </a:r>
            <a:r>
              <a:rPr lang="en-US" sz="750" dirty="0">
                <a:ea typeface="+mn-lt"/>
                <a:cs typeface="+mn-lt"/>
              </a:rPr>
              <a:t>with unequal slopes for sex: in all models, when any better response is compared to PD, women had significantly lower odds of that better cancer response than men. </a:t>
            </a:r>
          </a:p>
        </p:txBody>
      </p:sp>
    </p:spTree>
    <p:extLst>
      <p:ext uri="{BB962C8B-B14F-4D97-AF65-F5344CB8AC3E}">
        <p14:creationId xmlns:p14="http://schemas.microsoft.com/office/powerpoint/2010/main" val="3117413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5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nningham, Michael Montana</dc:creator>
  <cp:lastModifiedBy>MDPI</cp:lastModifiedBy>
  <cp:revision>2</cp:revision>
  <dcterms:created xsi:type="dcterms:W3CDTF">2025-06-16T16:55:06Z</dcterms:created>
  <dcterms:modified xsi:type="dcterms:W3CDTF">2025-06-17T03:52:15Z</dcterms:modified>
</cp:coreProperties>
</file>